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1F20E-16B5-41EA-B31B-9FF5A68712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BAD5E-A454-4AE5-B7C9-177B0E9A34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DB573-7DFB-4AFD-A7F7-CE644619CD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AD061-7314-4E18-9BAB-0D3EB134B5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7182A-BF4A-45D8-B38F-0353617E00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A2A67-288B-4BB5-9031-EE3E2E77A6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0A992-858E-4275-9BBE-9E572A1A12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465D7-E6CD-4052-A64C-CBC06C3F49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3DE29-E934-4A7A-B34C-DEE68E813F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4D544-705E-4168-9EFF-0072DE3FA5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87E23-8925-4ADB-A94E-197C4FA1B4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3CB34-C88F-4C79-8765-2F63640BDC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F1171B-433A-4339-BEBD-DDF8F4331E5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380880" y="351000"/>
            <a:ext cx="8305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Table S3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The role of VDR in induction of Total Cell Death (TD) as determined by Trypan blue exclus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9"/>
          <p:cNvSpPr/>
          <p:nvPr/>
        </p:nvSpPr>
        <p:spPr>
          <a:xfrm>
            <a:off x="764280" y="3624120"/>
            <a:ext cx="3937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B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AML blasts ex vivo ( Three patient samples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0"/>
          <p:cNvSpPr/>
          <p:nvPr/>
        </p:nvSpPr>
        <p:spPr>
          <a:xfrm>
            <a:off x="767160" y="914400"/>
            <a:ext cx="362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A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alibri"/>
              </a:rPr>
              <a:t>HL60 cells  ( Six individual experiments 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749160" y="3965400"/>
          <a:ext cx="7175520" cy="1714680"/>
        </p:xfrm>
        <a:graphic>
          <a:graphicData uri="http://schemas.openxmlformats.org/drawingml/2006/table">
            <a:tbl>
              <a:tblPr/>
              <a:tblGrid>
                <a:gridCol w="609840"/>
                <a:gridCol w="1562040"/>
                <a:gridCol w="609480"/>
                <a:gridCol w="609840"/>
                <a:gridCol w="609480"/>
                <a:gridCol w="609480"/>
                <a:gridCol w="609840"/>
                <a:gridCol w="812520"/>
                <a:gridCol w="1143000"/>
              </a:tblGrid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ML ex vivo-TB exlusion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s 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s corresp 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7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.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+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9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1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8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.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5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4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hr-D2+CA-96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8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2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1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8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+CA-96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3.7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3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 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4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7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3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hr-D2+CA-96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3.0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6%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7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380880" y="1222200"/>
          <a:ext cx="8534520" cy="1900440"/>
        </p:xfrm>
        <a:graphic>
          <a:graphicData uri="http://schemas.openxmlformats.org/drawingml/2006/table">
            <a:tbl>
              <a:tblPr/>
              <a:tblGrid>
                <a:gridCol w="424080"/>
                <a:gridCol w="1461960"/>
                <a:gridCol w="600120"/>
                <a:gridCol w="601560"/>
                <a:gridCol w="600120"/>
                <a:gridCol w="601560"/>
                <a:gridCol w="600120"/>
                <a:gridCol w="601920"/>
                <a:gridCol w="564840"/>
                <a:gridCol w="567000"/>
                <a:gridCol w="691920"/>
                <a:gridCol w="1219320"/>
              </a:tblGrid>
              <a:tr h="21132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L60-TB  exlus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s 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 vs corresp 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096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+CA-96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96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9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0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iCT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hr-D2+CA-96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0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9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6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0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096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trol-96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8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2+CA-96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.7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35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096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 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.3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1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0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0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1320"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siVD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raC-72hr-D2+CA-96h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1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.0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.2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8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0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864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ff"/>
                          </a:solidFill>
                          <a:latin typeface="Calibri"/>
                        </a:rPr>
                        <a:t>0.01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8640" marR="86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17T16:24:02Z</dcterms:created>
  <dc:creator>UmdNJ</dc:creator>
  <dc:description/>
  <dc:language>en-US</dc:language>
  <cp:lastModifiedBy>UmdNJ</cp:lastModifiedBy>
  <dcterms:modified xsi:type="dcterms:W3CDTF">2016-03-21T16:12:06Z</dcterms:modified>
  <cp:revision>17</cp:revision>
  <dc:subject/>
  <dc:title>Slide 1</dc:title>
</cp:coreProperties>
</file>